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937500" cy="114220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938000" cy="11422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440160" cy="57168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497480" y="0"/>
            <a:ext cx="3440160" cy="57168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63400" y="856800"/>
            <a:ext cx="3210120" cy="4280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93440" y="5425560"/>
            <a:ext cx="6351480" cy="513900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49748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b">
            <a:noAutofit/>
          </a:bodyPr>
          <a:lstStyle>
            <a:lvl1pPr indent="0" algn="r">
              <a:buNone/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  <a:defRPr b="0" lang="fr-FR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</a:pPr>
            <a:fld id="{76BD5104-6406-4915-A01A-A827AC1244F6}" type="slidenum">
              <a:rPr b="0" lang="fr-FR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Rectangle 7"/>
          <p:cNvSpPr/>
          <p:nvPr/>
        </p:nvSpPr>
        <p:spPr>
          <a:xfrm>
            <a:off x="449748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6560" rIns="106560" tIns="53280" bIns="53280" anchor="b">
            <a:noAutofit/>
          </a:bodyPr>
          <a:p>
            <a:pPr algn="r"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</a:pPr>
            <a:fld id="{76C2F055-E83F-49A2-9FEB-715D24F6E644}" type="slidenum">
              <a:rPr b="0" lang="fr-FR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1"/>
          <p:cNvSpPr>
            <a:spLocks noGrp="1"/>
          </p:cNvSpPr>
          <p:nvPr>
            <p:ph type="sldImg"/>
          </p:nvPr>
        </p:nvSpPr>
        <p:spPr>
          <a:xfrm>
            <a:off x="2363760" y="857160"/>
            <a:ext cx="3210120" cy="4280040"/>
          </a:xfrm>
          <a:prstGeom prst="rect">
            <a:avLst/>
          </a:prstGeom>
          <a:ln w="0">
            <a:noFill/>
          </a:ln>
        </p:spPr>
      </p:sp>
      <p:sp>
        <p:nvSpPr>
          <p:cNvPr id="200" name="PlaceHolder 2"/>
          <p:cNvSpPr>
            <a:spLocks noGrp="1"/>
          </p:cNvSpPr>
          <p:nvPr>
            <p:ph type="body"/>
          </p:nvPr>
        </p:nvSpPr>
        <p:spPr>
          <a:xfrm>
            <a:off x="793440" y="5425560"/>
            <a:ext cx="6351480" cy="5148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646A2-C16D-4934-BF7B-5E54637E54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C1834-2055-4ACE-B4E0-22103D68A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F5C92-D8CD-4201-8B1E-1998F8FA9A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4E564-DFE9-4A68-ABFF-D0E242BA02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08ACA-E543-4DB9-8EE9-466036F0BD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2A08B-5DEC-4AE6-865E-7E4BD6501F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4A5AA-DDE4-4D52-9639-AD013A6A1B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003C9-9314-4E6E-AD49-E068299C89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79728-07EF-4E3F-BDB4-9ABA8A069A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4C7C4-FE02-47FE-89C7-0B32ECFF6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089FA-EAF9-46EC-BAEA-7F0F6CF24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75974-39FA-420B-BEE8-6F43EC34D1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4F246B-0B96-4129-AED3-E0294103E4D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237240" y="3445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37240" y="25844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37240" y="49672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3044880" y="5437080"/>
            <a:ext cx="1888920" cy="1659240"/>
            <a:chOff x="3044880" y="5437080"/>
            <a:chExt cx="1888920" cy="1659240"/>
          </a:xfrm>
        </p:grpSpPr>
        <p:sp>
          <p:nvSpPr>
            <p:cNvPr id="52" name=""/>
            <p:cNvSpPr/>
            <p:nvPr/>
          </p:nvSpPr>
          <p:spPr>
            <a:xfrm>
              <a:off x="3951360" y="5746680"/>
              <a:ext cx="231840" cy="1106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529160" y="6121440"/>
              <a:ext cx="231840" cy="731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065480" y="574668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057560" y="574668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4643280" y="5979600"/>
              <a:ext cx="0" cy="141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626000" y="5979960"/>
              <a:ext cx="39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778200" y="5526000"/>
              <a:ext cx="0" cy="1326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736800" y="663084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736800" y="641196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736800" y="618948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736800" y="596556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736800" y="574668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736800" y="552600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778200" y="6852960"/>
              <a:ext cx="1155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736800" y="6852960"/>
              <a:ext cx="4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3778200" y="6852600"/>
              <a:ext cx="0" cy="39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4356000" y="6852600"/>
              <a:ext cx="0" cy="39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4933800" y="6852600"/>
              <a:ext cx="0" cy="39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595680" y="67467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471840" y="65419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471840" y="6324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471840" y="6100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471840" y="58784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471840" y="56610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471840" y="54370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27"/>
            <p:cNvSpPr/>
            <p:nvPr/>
          </p:nvSpPr>
          <p:spPr>
            <a:xfrm rot="16200000">
              <a:off x="2567160" y="5998680"/>
              <a:ext cx="13208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FANC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956040" y="691344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405320" y="6913440"/>
              <a:ext cx="477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342600" y="691344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523800" y="5429160"/>
            <a:ext cx="1886040" cy="1663920"/>
            <a:chOff x="523800" y="5429160"/>
            <a:chExt cx="1886040" cy="1663920"/>
          </a:xfrm>
        </p:grpSpPr>
        <p:sp>
          <p:nvSpPr>
            <p:cNvPr id="82" name=""/>
            <p:cNvSpPr/>
            <p:nvPr/>
          </p:nvSpPr>
          <p:spPr>
            <a:xfrm>
              <a:off x="1440000" y="5744880"/>
              <a:ext cx="231480" cy="11080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013120" y="6202080"/>
              <a:ext cx="226800" cy="650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2125800" y="6019200"/>
              <a:ext cx="0" cy="18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109960" y="601956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270080" y="6852960"/>
              <a:ext cx="1139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7" name=""/>
            <p:cNvGrpSpPr/>
            <p:nvPr/>
          </p:nvGrpSpPr>
          <p:grpSpPr>
            <a:xfrm>
              <a:off x="1227240" y="5519520"/>
              <a:ext cx="42120" cy="1374480"/>
              <a:chOff x="1227240" y="5519520"/>
              <a:chExt cx="42120" cy="1374480"/>
            </a:xfrm>
          </p:grpSpPr>
          <p:sp>
            <p:nvSpPr>
              <p:cNvPr id="88" name=""/>
              <p:cNvSpPr/>
              <p:nvPr/>
            </p:nvSpPr>
            <p:spPr>
              <a:xfrm>
                <a:off x="1269360" y="5519520"/>
                <a:ext cx="0" cy="1333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227240" y="685296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227240" y="662904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227240" y="640548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227240" y="619272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227240" y="596880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227240" y="574488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227240" y="5519520"/>
                <a:ext cx="4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1269360" y="6852600"/>
                <a:ext cx="0" cy="41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"/>
            <p:cNvSpPr/>
            <p:nvPr/>
          </p:nvSpPr>
          <p:spPr>
            <a:xfrm flipV="1">
              <a:off x="1843200" y="685260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2409840" y="6852600"/>
              <a:ext cx="0" cy="41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945720" y="65386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945720" y="6315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945720" y="6100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945720" y="58766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945720" y="56530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945720" y="54291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27"/>
            <p:cNvSpPr/>
            <p:nvPr/>
          </p:nvSpPr>
          <p:spPr>
            <a:xfrm rot="16200000">
              <a:off x="46080" y="5993640"/>
              <a:ext cx="13208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Hsp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" name=""/>
            <p:cNvGrpSpPr/>
            <p:nvPr/>
          </p:nvGrpSpPr>
          <p:grpSpPr>
            <a:xfrm>
              <a:off x="824760" y="6743520"/>
              <a:ext cx="1540440" cy="349560"/>
              <a:chOff x="824760" y="6743520"/>
              <a:chExt cx="1540440" cy="349560"/>
            </a:xfrm>
          </p:grpSpPr>
          <p:sp>
            <p:nvSpPr>
              <p:cNvPr id="107" name=""/>
              <p:cNvSpPr/>
              <p:nvPr/>
            </p:nvSpPr>
            <p:spPr>
              <a:xfrm>
                <a:off x="1077480" y="67435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438200" y="691020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tr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1887480" y="6910200"/>
                <a:ext cx="477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400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824760" y="6910200"/>
                <a:ext cx="432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1" name=""/>
          <p:cNvGrpSpPr/>
          <p:nvPr/>
        </p:nvGrpSpPr>
        <p:grpSpPr>
          <a:xfrm>
            <a:off x="527040" y="3111480"/>
            <a:ext cx="1887480" cy="1676520"/>
            <a:chOff x="527040" y="3111480"/>
            <a:chExt cx="1887480" cy="1676520"/>
          </a:xfrm>
        </p:grpSpPr>
        <p:sp>
          <p:nvSpPr>
            <p:cNvPr id="112" name=""/>
            <p:cNvSpPr/>
            <p:nvPr/>
          </p:nvSpPr>
          <p:spPr>
            <a:xfrm>
              <a:off x="1442880" y="4087800"/>
              <a:ext cx="225720" cy="449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273320" y="4537080"/>
              <a:ext cx="1141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273320" y="3192480"/>
              <a:ext cx="0" cy="1344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230480" y="45370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230480" y="431316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230480" y="40878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230480" y="38638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230480" y="363996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230480" y="34160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230480" y="31924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1273320" y="4537080"/>
              <a:ext cx="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1843200" y="4537080"/>
              <a:ext cx="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2414520" y="4537080"/>
              <a:ext cx="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955800" y="42307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955800" y="40068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955800" y="3782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955800" y="3558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955800" y="33354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955800" y="3111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27"/>
            <p:cNvSpPr/>
            <p:nvPr/>
          </p:nvSpPr>
          <p:spPr>
            <a:xfrm rot="16200000">
              <a:off x="49320" y="3669840"/>
              <a:ext cx="13208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TP53IN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2128680" y="3565440"/>
              <a:ext cx="0" cy="169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112840" y="3565440"/>
              <a:ext cx="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013120" y="3701880"/>
              <a:ext cx="226800" cy="835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" name=""/>
            <p:cNvGrpSpPr/>
            <p:nvPr/>
          </p:nvGrpSpPr>
          <p:grpSpPr>
            <a:xfrm>
              <a:off x="821520" y="4438440"/>
              <a:ext cx="1540440" cy="349560"/>
              <a:chOff x="821520" y="4438440"/>
              <a:chExt cx="1540440" cy="349560"/>
            </a:xfrm>
          </p:grpSpPr>
          <p:sp>
            <p:nvSpPr>
              <p:cNvPr id="136" name=""/>
              <p:cNvSpPr/>
              <p:nvPr/>
            </p:nvSpPr>
            <p:spPr>
              <a:xfrm>
                <a:off x="1074240" y="443844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434960" y="460512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tr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884240" y="4605120"/>
                <a:ext cx="477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400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821520" y="4605120"/>
                <a:ext cx="432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0" name=""/>
          <p:cNvGrpSpPr/>
          <p:nvPr/>
        </p:nvGrpSpPr>
        <p:grpSpPr>
          <a:xfrm>
            <a:off x="3035160" y="3117960"/>
            <a:ext cx="1893960" cy="1666800"/>
            <a:chOff x="3035160" y="3117960"/>
            <a:chExt cx="1893960" cy="1666800"/>
          </a:xfrm>
        </p:grpSpPr>
        <p:sp>
          <p:nvSpPr>
            <p:cNvPr id="141" name=""/>
            <p:cNvSpPr/>
            <p:nvPr/>
          </p:nvSpPr>
          <p:spPr>
            <a:xfrm flipV="1">
              <a:off x="4632480" y="3457080"/>
              <a:ext cx="0" cy="253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616280" y="3457440"/>
              <a:ext cx="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951360" y="4093920"/>
              <a:ext cx="234720" cy="4474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780000" y="4541760"/>
              <a:ext cx="1149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780000" y="3208320"/>
              <a:ext cx="0" cy="133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736800" y="454176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736800" y="431784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736800" y="409392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736800" y="388116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736800" y="365760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736800" y="343368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736800" y="3208320"/>
              <a:ext cx="43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3780000" y="4541760"/>
              <a:ext cx="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4357800" y="4541760"/>
              <a:ext cx="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4929120" y="4541760"/>
              <a:ext cx="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3461040" y="4227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461040" y="4003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461040" y="37893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461040" y="35654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461040" y="33415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3461040" y="3117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27"/>
            <p:cNvSpPr/>
            <p:nvPr/>
          </p:nvSpPr>
          <p:spPr>
            <a:xfrm rot="16200000">
              <a:off x="2557440" y="3698280"/>
              <a:ext cx="13204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p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529160" y="3697200"/>
              <a:ext cx="228600" cy="844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4" name=""/>
            <p:cNvGrpSpPr/>
            <p:nvPr/>
          </p:nvGrpSpPr>
          <p:grpSpPr>
            <a:xfrm>
              <a:off x="3332880" y="4435200"/>
              <a:ext cx="1540440" cy="349560"/>
              <a:chOff x="3332880" y="4435200"/>
              <a:chExt cx="1540440" cy="349560"/>
            </a:xfrm>
          </p:grpSpPr>
          <p:sp>
            <p:nvSpPr>
              <p:cNvPr id="165" name=""/>
              <p:cNvSpPr/>
              <p:nvPr/>
            </p:nvSpPr>
            <p:spPr>
              <a:xfrm>
                <a:off x="3585600" y="443520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946320" y="460188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tr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395600" y="4601880"/>
                <a:ext cx="477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400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3332880" y="4601880"/>
                <a:ext cx="432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9" name=""/>
          <p:cNvGrpSpPr/>
          <p:nvPr/>
        </p:nvGrpSpPr>
        <p:grpSpPr>
          <a:xfrm>
            <a:off x="509760" y="851040"/>
            <a:ext cx="1904760" cy="1672920"/>
            <a:chOff x="509760" y="851040"/>
            <a:chExt cx="1904760" cy="1672920"/>
          </a:xfrm>
        </p:grpSpPr>
        <p:sp>
          <p:nvSpPr>
            <p:cNvPr id="170" name="Rectangle 27"/>
            <p:cNvSpPr/>
            <p:nvPr/>
          </p:nvSpPr>
          <p:spPr>
            <a:xfrm rot="16200000">
              <a:off x="51120" y="1405800"/>
              <a:ext cx="12823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p400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965520" y="19699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965520" y="17460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965520" y="15220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965520" y="12981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965520" y="10742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965520" y="851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441440" y="1171080"/>
              <a:ext cx="227160" cy="1120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013120" y="1925280"/>
              <a:ext cx="226800" cy="366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2124000" y="1812600"/>
              <a:ext cx="0" cy="11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109960" y="181260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271520" y="2292120"/>
              <a:ext cx="1143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271520" y="947520"/>
              <a:ext cx="0" cy="134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228680" y="22921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228680" y="20682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228680" y="18428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228680" y="16189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228680" y="13950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228680" y="11710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228680" y="9475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>
              <a:off x="1271520" y="2291760"/>
              <a:ext cx="0" cy="3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1843200" y="2291760"/>
              <a:ext cx="0" cy="3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2414520" y="2291760"/>
              <a:ext cx="0" cy="3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3" name=""/>
            <p:cNvGrpSpPr/>
            <p:nvPr/>
          </p:nvGrpSpPr>
          <p:grpSpPr>
            <a:xfrm>
              <a:off x="843840" y="2174400"/>
              <a:ext cx="1540440" cy="349560"/>
              <a:chOff x="843840" y="2174400"/>
              <a:chExt cx="1540440" cy="349560"/>
            </a:xfrm>
          </p:grpSpPr>
          <p:sp>
            <p:nvSpPr>
              <p:cNvPr id="194" name=""/>
              <p:cNvSpPr/>
              <p:nvPr/>
            </p:nvSpPr>
            <p:spPr>
              <a:xfrm>
                <a:off x="1096560" y="217440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457280" y="234108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Ctr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906560" y="2341080"/>
                <a:ext cx="477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p400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843840" y="2341080"/>
                <a:ext cx="432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09T13:57:35Z</dcterms:created>
  <dc:creator>stouflette moumoute</dc:creator>
  <dc:description/>
  <dc:language>en-US</dc:language>
  <cp:lastModifiedBy>escaffit</cp:lastModifiedBy>
  <cp:lastPrinted>2009-07-21T09:02:30Z</cp:lastPrinted>
  <dcterms:modified xsi:type="dcterms:W3CDTF">2010-04-08T08:57:33Z</dcterms:modified>
  <cp:revision>110</cp:revision>
  <dc:subject/>
  <dc:title>PowerPoint Presentation</dc:title>
</cp:coreProperties>
</file>